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0" d="100"/>
          <a:sy n="70" d="100"/>
        </p:scale>
        <p:origin x="3846" y="6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84787-8691-4D1D-9CB3-D07DBD17991E}" type="datetimeFigureOut">
              <a:rPr lang="en-US" smtClean="0"/>
              <a:t>2/2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58E6D4-734A-4107-8A60-4EEDA8D969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06520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84787-8691-4D1D-9CB3-D07DBD17991E}" type="datetimeFigureOut">
              <a:rPr lang="en-US" smtClean="0"/>
              <a:t>2/2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58E6D4-734A-4107-8A60-4EEDA8D969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40118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84787-8691-4D1D-9CB3-D07DBD17991E}" type="datetimeFigureOut">
              <a:rPr lang="en-US" smtClean="0"/>
              <a:t>2/2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58E6D4-734A-4107-8A60-4EEDA8D969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27749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84787-8691-4D1D-9CB3-D07DBD17991E}" type="datetimeFigureOut">
              <a:rPr lang="en-US" smtClean="0"/>
              <a:t>2/2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58E6D4-734A-4107-8A60-4EEDA8D969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39192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84787-8691-4D1D-9CB3-D07DBD17991E}" type="datetimeFigureOut">
              <a:rPr lang="en-US" smtClean="0"/>
              <a:t>2/2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58E6D4-734A-4107-8A60-4EEDA8D969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73176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84787-8691-4D1D-9CB3-D07DBD17991E}" type="datetimeFigureOut">
              <a:rPr lang="en-US" smtClean="0"/>
              <a:t>2/24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58E6D4-734A-4107-8A60-4EEDA8D969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96850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84787-8691-4D1D-9CB3-D07DBD17991E}" type="datetimeFigureOut">
              <a:rPr lang="en-US" smtClean="0"/>
              <a:t>2/24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58E6D4-734A-4107-8A60-4EEDA8D969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9306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84787-8691-4D1D-9CB3-D07DBD17991E}" type="datetimeFigureOut">
              <a:rPr lang="en-US" smtClean="0"/>
              <a:t>2/24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58E6D4-734A-4107-8A60-4EEDA8D969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43933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84787-8691-4D1D-9CB3-D07DBD17991E}" type="datetimeFigureOut">
              <a:rPr lang="en-US" smtClean="0"/>
              <a:t>2/24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58E6D4-734A-4107-8A60-4EEDA8D969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52817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84787-8691-4D1D-9CB3-D07DBD17991E}" type="datetimeFigureOut">
              <a:rPr lang="en-US" smtClean="0"/>
              <a:t>2/24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58E6D4-734A-4107-8A60-4EEDA8D969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27499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84787-8691-4D1D-9CB3-D07DBD17991E}" type="datetimeFigureOut">
              <a:rPr lang="en-US" smtClean="0"/>
              <a:t>2/24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58E6D4-734A-4107-8A60-4EEDA8D969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49708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784787-8691-4D1D-9CB3-D07DBD17991E}" type="datetimeFigureOut">
              <a:rPr lang="en-US" smtClean="0"/>
              <a:t>2/2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58E6D4-734A-4107-8A60-4EEDA8D969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86960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9288" y="50801"/>
            <a:ext cx="5522912" cy="8085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Rectangle 1"/>
          <p:cNvSpPr/>
          <p:nvPr/>
        </p:nvSpPr>
        <p:spPr>
          <a:xfrm>
            <a:off x="685800" y="8229600"/>
            <a:ext cx="5562600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latin typeface="Arial" pitchFamily="34" charset="0"/>
                <a:cs typeface="Arial" pitchFamily="34" charset="0"/>
              </a:rPr>
              <a:t>Supplemental </a:t>
            </a:r>
            <a:r>
              <a:rPr lang="en-US" sz="1000" b="1">
                <a:latin typeface="Arial" pitchFamily="34" charset="0"/>
                <a:cs typeface="Arial" pitchFamily="34" charset="0"/>
              </a:rPr>
              <a:t>Figure </a:t>
            </a:r>
            <a:r>
              <a:rPr lang="en-US" sz="1000" b="1" smtClean="0">
                <a:latin typeface="Arial" pitchFamily="34" charset="0"/>
                <a:cs typeface="Arial" pitchFamily="34" charset="0"/>
              </a:rPr>
              <a:t>S3.  </a:t>
            </a:r>
            <a:r>
              <a:rPr lang="en-US" sz="1000" b="1" dirty="0">
                <a:latin typeface="Arial" pitchFamily="34" charset="0"/>
                <a:cs typeface="Arial" pitchFamily="34" charset="0"/>
              </a:rPr>
              <a:t>MYC activation/deactivation.</a:t>
            </a:r>
            <a:r>
              <a:rPr lang="en-US" sz="1000" dirty="0">
                <a:latin typeface="Arial" pitchFamily="34" charset="0"/>
                <a:cs typeface="Arial" pitchFamily="34" charset="0"/>
              </a:rPr>
              <a:t>  Ingenuity Pathway Analysis (</a:t>
            </a:r>
            <a:r>
              <a:rPr lang="en-US" sz="1000" dirty="0" err="1">
                <a:latin typeface="Arial" pitchFamily="34" charset="0"/>
                <a:cs typeface="Arial" pitchFamily="34" charset="0"/>
              </a:rPr>
              <a:t>Qiagen</a:t>
            </a:r>
            <a:r>
              <a:rPr lang="en-US" sz="1000" dirty="0">
                <a:latin typeface="Arial" pitchFamily="34" charset="0"/>
                <a:cs typeface="Arial" pitchFamily="34" charset="0"/>
              </a:rPr>
              <a:t>) analysis of differentially expressed genes of T47D breast cancer cells under the following conditions:   A. R5020 [10nM] vs. Control and B.  R5020 [10nM] vs. R5020 [10nM] + TPA [1µM] identified MYC as a significant upstream effector.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828045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63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oi, MiRan</dc:creator>
  <cp:lastModifiedBy>Susan E Clare</cp:lastModifiedBy>
  <cp:revision>5</cp:revision>
  <dcterms:created xsi:type="dcterms:W3CDTF">2015-03-13T16:37:31Z</dcterms:created>
  <dcterms:modified xsi:type="dcterms:W3CDTF">2016-02-24T16:48:44Z</dcterms:modified>
</cp:coreProperties>
</file>